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2" r:id="rId7"/>
    <p:sldId id="263" r:id="rId8"/>
    <p:sldId id="259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49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Griffin et al </a:t>
            </a:r>
            <a:r>
              <a:rPr lang="en-GB" dirty="0"/>
              <a:t>(2017) </a:t>
            </a:r>
            <a:r>
              <a:rPr lang="en-GB" dirty="0" err="1"/>
              <a:t>Diabetologia</a:t>
            </a:r>
            <a:r>
              <a:rPr lang="en-GB" dirty="0" smtClean="0"/>
              <a:t> DOI 10.1007/s00125-017-4337-9</a:t>
            </a:r>
          </a:p>
          <a:p>
            <a:r>
              <a:rPr lang="en-GB" sz="1400" dirty="0"/>
              <a:t>© The </a:t>
            </a:r>
            <a:r>
              <a:rPr lang="en-GB" sz="1400" dirty="0" smtClean="0"/>
              <a:t>Authors</a:t>
            </a:r>
            <a:endParaRPr lang="en-GB" sz="1400" dirty="0"/>
          </a:p>
          <a:p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eferred Reporting Items for Systematic Reviews and Meta-Analyses (PRISMA) flow diagram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5391" y="1056802"/>
            <a:ext cx="4129201" cy="4892478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95536" y="5876404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8813" y="332656"/>
            <a:ext cx="2919634" cy="5592885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6444813" y="1506214"/>
            <a:ext cx="2466635" cy="1271211"/>
            <a:chOff x="459350" y="1398934"/>
            <a:chExt cx="2466635" cy="127121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9350" y="1398934"/>
              <a:ext cx="454997" cy="478633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9442" y="2244077"/>
              <a:ext cx="420150" cy="42606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3250" y="1853564"/>
              <a:ext cx="396342" cy="390513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870447" y="1441036"/>
              <a:ext cx="2055538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U</a:t>
              </a:r>
              <a:r>
                <a:rPr lang="en-GB" dirty="0" smtClean="0"/>
                <a:t>nclear </a:t>
              </a:r>
              <a:r>
                <a:rPr lang="en-GB" dirty="0"/>
                <a:t>risk of </a:t>
              </a:r>
              <a:r>
                <a:rPr lang="en-GB" dirty="0" smtClean="0"/>
                <a:t>bias </a:t>
              </a:r>
            </a:p>
            <a:p>
              <a:endParaRPr lang="en-GB" sz="800" dirty="0"/>
            </a:p>
            <a:p>
              <a:r>
                <a:rPr lang="en-GB" dirty="0" smtClean="0"/>
                <a:t>High </a:t>
              </a:r>
              <a:r>
                <a:rPr lang="en-GB" dirty="0"/>
                <a:t>risk of </a:t>
              </a:r>
              <a:r>
                <a:rPr lang="en-GB" dirty="0" smtClean="0"/>
                <a:t>bias </a:t>
              </a:r>
            </a:p>
            <a:p>
              <a:endParaRPr lang="en-GB" sz="800" dirty="0"/>
            </a:p>
            <a:p>
              <a:r>
                <a:rPr lang="en-GB" dirty="0" smtClean="0"/>
                <a:t>Low </a:t>
              </a:r>
              <a:r>
                <a:rPr lang="en-GB" dirty="0"/>
                <a:t>risk of bias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95536" y="260648"/>
            <a:ext cx="3240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isk of bias summary</a:t>
            </a:r>
          </a:p>
        </p:txBody>
      </p:sp>
    </p:spTree>
    <p:extLst>
      <p:ext uri="{BB962C8B-B14F-4D97-AF65-F5344CB8AC3E}">
        <p14:creationId xmlns:p14="http://schemas.microsoft.com/office/powerpoint/2010/main" val="217523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the effect of metformin on risk of all-cause mortality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1484784"/>
            <a:ext cx="8779843" cy="4034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741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the effect of metformin on risk of cardiovascular death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1484784"/>
            <a:ext cx="8815227" cy="40142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92910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the effect of metformin on risk of myocardial infarction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861" y="1844824"/>
            <a:ext cx="8731936" cy="3127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5834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the effect of metformin on risk of stroke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120" y="1867703"/>
            <a:ext cx="8861376" cy="2705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7134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260648"/>
            <a:ext cx="88204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the effect of metformin on risk of peripheral vascular disease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512" y="1974187"/>
            <a:ext cx="8765455" cy="24920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3208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Griffin et al (2017) </a:t>
            </a:r>
            <a:r>
              <a:rPr lang="en-GB" dirty="0" err="1"/>
              <a:t>Diabetologia</a:t>
            </a:r>
            <a:r>
              <a:rPr lang="en-GB" dirty="0"/>
              <a:t> DOI 10.1007/s00125-017-4337-9</a:t>
            </a:r>
          </a:p>
          <a:p>
            <a:r>
              <a:rPr lang="en-GB" sz="1400" dirty="0"/>
              <a:t>© The Autho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unnel plot of effect size estimates for all-cause mortality to assess risk of publication bia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576" y="1340768"/>
            <a:ext cx="7207097" cy="4605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4098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200</Words>
  <Application>Microsoft Office PowerPoint</Application>
  <PresentationFormat>On-screen Show (4:3)</PresentationFormat>
  <Paragraphs>3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S Ruffino</cp:lastModifiedBy>
  <cp:revision>22</cp:revision>
  <dcterms:created xsi:type="dcterms:W3CDTF">2016-06-15T12:53:43Z</dcterms:created>
  <dcterms:modified xsi:type="dcterms:W3CDTF">2017-06-28T10:07:19Z</dcterms:modified>
</cp:coreProperties>
</file>